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37"/>
    <p:restoredTop sz="94646"/>
  </p:normalViewPr>
  <p:slideViewPr>
    <p:cSldViewPr snapToGrid="0">
      <p:cViewPr varScale="1">
        <p:scale>
          <a:sx n="89" d="100"/>
          <a:sy n="89" d="100"/>
        </p:scale>
        <p:origin x="10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7B785D-2647-B041-BD51-E1546F5DB371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99EF92-EE7D-E842-ACC8-8C009ED368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139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218993-6F8F-845D-1E28-9E0032564A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FEB0C27-7910-8E68-4FA9-178AD144A7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8F04F5-6C50-2F1F-B0CD-4D89ACF18D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B45FFA-DFC1-EEEC-18BB-298BFDB9D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91ABFF-DC34-0E8E-AB39-C53079C10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458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823F89-C2E1-4F6D-C6C1-739D30C137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31B9A97-B6F7-2DDE-B567-023792F8A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5C1908-6524-A668-22EF-AB635E960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12F03F-92A4-346A-FFDF-AEF343D92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45CAA6-0F7C-4E23-2449-0A7F17602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1258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1E18E70-A7AA-B4AE-CA14-4E2CA48089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366416C-3FE3-2BD9-FF83-79DA37D729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95EE09-F1B4-78F3-3C1F-64AFF5F2C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533481-7D8D-E914-85B3-3C06DC52F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735CA9-CD77-08AF-7A40-6A739E64B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92370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81D7B1-1AEE-0630-254F-BDB3C3279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AA2D9B8-AC66-512C-8D47-C1E77C9711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977378-B309-5ABD-1CA8-03AF916010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284E1FA-1A03-8EA0-6C21-42E4026DA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D14D1D-7BA5-96AA-F203-54B12BB1D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6867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23BA36-D1A6-950E-3A15-0704DF7A9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6EAAD8F-5984-D08A-C0EB-93306FCFD6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5C74FF-D16A-073E-663D-71E54040F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24F94D-2F48-0B35-E672-FF1DBFF14D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FDB4DD7-B739-D67D-2FD1-873BB9D43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706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2FF70B-4FA1-009B-E916-E83B603D7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030D43-D466-7D70-9D95-F4BF2553FF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8F7222-EDE8-E39C-D6DA-2D37C1613A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747E5F1-D9C9-AB56-DDA2-32187A242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936AA2-CA7B-F48C-9197-E499C2B9B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69B0EC3-EAC5-77C4-C229-09FDBCB37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054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DF535D-0FAA-C318-60FF-518753F15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F27F2B6-EE9A-9F01-EB7C-86A9FC1E55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07D79D9-6A86-8B69-96D3-3F48404768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B8979DC-751C-9AED-0E76-5DA3FC9305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75E70E9-9E7A-13CE-0317-3F93FCA980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618E198-B78E-2C89-3A9C-DCFD471CD9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C9C5B69-E339-2E5E-FB3F-9977AE466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BB874D5-27AC-825F-E949-9699793155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0387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49CF67-9D6A-C8B4-EB70-DCBA0655AE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A521DBB-15AC-B67F-E6F7-ACB5D94BC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766A057-6EC0-E33D-7287-79A06D2EE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277C6DF-B84C-627C-0ADD-FF8811B1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8544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9E37CD0-FE9D-FCCF-2DB2-62ABB2C26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D8910CC-4228-77BC-6A45-76F3FD172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E3C6E40-97B6-FDE3-66EF-DE0823413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930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B52F6E-69C2-F71F-A332-AA417E32FD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598E8E-0D9E-BA3B-1E7E-FCF252BB7A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282FEE-1340-B35E-D8C4-25999081C4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2A34577-CF6E-5BA2-DF92-80B48B4BF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4951D5-B4FC-0081-FDDC-816893DC7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14FB8B3-FAF0-FC1F-C1E8-130280C59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1763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51F374-B4B6-FDD7-14BB-350EFF76A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6637429-02CA-2E3A-9C24-137E9F7D5B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C87EEDF-953A-5E36-192D-330AECA3A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AC2CE9F-7CB3-C32D-D4C0-BA90D1457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EC63744-8E8C-3B1E-0AAD-26CA84135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C36B01E-AA2F-F571-6712-305FA32D4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2963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C76E01B-F4E1-0755-6A4D-5425C7EDC8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826E65-4F16-4A72-7E0D-51E59D617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DF17779-2E1E-A86D-93DF-22F2E14F1F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BF2A3-E21C-EE40-B8E3-494C4FBEF156}" type="datetimeFigureOut">
              <a:rPr kumimoji="1" lang="ja-JP" altLang="en-US" smtClean="0"/>
              <a:t>2023/8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C1962D-0DAB-169F-1EB3-9C52411E52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EB6C66-F7A0-30A3-3E7D-CC0CCC1C5A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1336C-DE3C-094C-A6D0-B6ADC8FB4B5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8826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8">
            <a:extLst>
              <a:ext uri="{FF2B5EF4-FFF2-40B4-BE49-F238E27FC236}">
                <a16:creationId xmlns:a16="http://schemas.microsoft.com/office/drawing/2014/main" id="{F83092C2-56DB-F84F-85E9-8B5A3CE17A29}"/>
              </a:ext>
            </a:extLst>
          </p:cNvPr>
          <p:cNvSpPr txBox="1"/>
          <p:nvPr/>
        </p:nvSpPr>
        <p:spPr>
          <a:xfrm>
            <a:off x="880780" y="6265964"/>
            <a:ext cx="10661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ry Figure </a:t>
            </a:r>
            <a:r>
              <a:rPr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2.</a:t>
            </a:r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 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nlarged HE stained image of the tumor section trimmed by microdissection. </a:t>
            </a:r>
            <a:endParaRPr lang="ja-JP" altLang="en-US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5" name="図 1">
            <a:extLst>
              <a:ext uri="{FF2B5EF4-FFF2-40B4-BE49-F238E27FC236}">
                <a16:creationId xmlns:a16="http://schemas.microsoft.com/office/drawing/2014/main" id="{01E4797C-B93D-8345-8FC7-25E74D7CA3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0125" y="528640"/>
            <a:ext cx="10194885" cy="5370520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8AE5C89A-678C-CF48-A22E-D7C397770AC3}"/>
              </a:ext>
            </a:extLst>
          </p:cNvPr>
          <p:cNvCxnSpPr/>
          <p:nvPr/>
        </p:nvCxnSpPr>
        <p:spPr>
          <a:xfrm>
            <a:off x="4800016" y="5482023"/>
            <a:ext cx="583989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7">
            <a:extLst>
              <a:ext uri="{FF2B5EF4-FFF2-40B4-BE49-F238E27FC236}">
                <a16:creationId xmlns:a16="http://schemas.microsoft.com/office/drawing/2014/main" id="{513D5DD2-7775-9E42-B80D-998591AA5E2C}"/>
              </a:ext>
            </a:extLst>
          </p:cNvPr>
          <p:cNvCxnSpPr>
            <a:cxnSpLocks/>
          </p:cNvCxnSpPr>
          <p:nvPr/>
        </p:nvCxnSpPr>
        <p:spPr>
          <a:xfrm>
            <a:off x="10631020" y="5473132"/>
            <a:ext cx="0" cy="18660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9">
            <a:extLst>
              <a:ext uri="{FF2B5EF4-FFF2-40B4-BE49-F238E27FC236}">
                <a16:creationId xmlns:a16="http://schemas.microsoft.com/office/drawing/2014/main" id="{2A846B96-6BCE-994A-AD6B-050285650B33}"/>
              </a:ext>
            </a:extLst>
          </p:cNvPr>
          <p:cNvCxnSpPr>
            <a:cxnSpLocks/>
          </p:cNvCxnSpPr>
          <p:nvPr/>
        </p:nvCxnSpPr>
        <p:spPr>
          <a:xfrm>
            <a:off x="4810195" y="5473132"/>
            <a:ext cx="0" cy="18660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10">
            <a:extLst>
              <a:ext uri="{FF2B5EF4-FFF2-40B4-BE49-F238E27FC236}">
                <a16:creationId xmlns:a16="http://schemas.microsoft.com/office/drawing/2014/main" id="{5A8FDD38-91D1-C841-82F4-60DADFD1F425}"/>
              </a:ext>
            </a:extLst>
          </p:cNvPr>
          <p:cNvCxnSpPr>
            <a:cxnSpLocks/>
          </p:cNvCxnSpPr>
          <p:nvPr/>
        </p:nvCxnSpPr>
        <p:spPr>
          <a:xfrm>
            <a:off x="8713552" y="5475322"/>
            <a:ext cx="0" cy="18660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11">
            <a:extLst>
              <a:ext uri="{FF2B5EF4-FFF2-40B4-BE49-F238E27FC236}">
                <a16:creationId xmlns:a16="http://schemas.microsoft.com/office/drawing/2014/main" id="{B7F6EEB8-55FA-184C-986F-81FB8A8C69C5}"/>
              </a:ext>
            </a:extLst>
          </p:cNvPr>
          <p:cNvCxnSpPr>
            <a:cxnSpLocks/>
          </p:cNvCxnSpPr>
          <p:nvPr/>
        </p:nvCxnSpPr>
        <p:spPr>
          <a:xfrm>
            <a:off x="6757557" y="5482023"/>
            <a:ext cx="0" cy="18660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2">
            <a:extLst>
              <a:ext uri="{FF2B5EF4-FFF2-40B4-BE49-F238E27FC236}">
                <a16:creationId xmlns:a16="http://schemas.microsoft.com/office/drawing/2014/main" id="{382D846E-B306-5245-A679-E7B58F2EAA5F}"/>
              </a:ext>
            </a:extLst>
          </p:cNvPr>
          <p:cNvSpPr txBox="1"/>
          <p:nvPr/>
        </p:nvSpPr>
        <p:spPr>
          <a:xfrm>
            <a:off x="4685467" y="5626789"/>
            <a:ext cx="133619" cy="308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0</a:t>
            </a:r>
            <a:endParaRPr kumimoji="1" lang="ja-JP" altLang="en-US" sz="1400"/>
          </a:p>
        </p:txBody>
      </p:sp>
      <p:sp>
        <p:nvSpPr>
          <p:cNvPr id="12" name="テキスト ボックス 13">
            <a:extLst>
              <a:ext uri="{FF2B5EF4-FFF2-40B4-BE49-F238E27FC236}">
                <a16:creationId xmlns:a16="http://schemas.microsoft.com/office/drawing/2014/main" id="{AC9D2124-A87E-2646-9822-E4AAE3ACE392}"/>
              </a:ext>
            </a:extLst>
          </p:cNvPr>
          <p:cNvSpPr txBox="1"/>
          <p:nvPr/>
        </p:nvSpPr>
        <p:spPr>
          <a:xfrm>
            <a:off x="6508352" y="5626366"/>
            <a:ext cx="550201" cy="3088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200</a:t>
            </a:r>
            <a:endParaRPr kumimoji="1" lang="ja-JP" altLang="en-US" sz="1400"/>
          </a:p>
        </p:txBody>
      </p:sp>
      <p:sp>
        <p:nvSpPr>
          <p:cNvPr id="13" name="テキスト ボックス 14">
            <a:extLst>
              <a:ext uri="{FF2B5EF4-FFF2-40B4-BE49-F238E27FC236}">
                <a16:creationId xmlns:a16="http://schemas.microsoft.com/office/drawing/2014/main" id="{1BA072E9-308E-334C-B921-C4EA8DC3249D}"/>
              </a:ext>
            </a:extLst>
          </p:cNvPr>
          <p:cNvSpPr txBox="1"/>
          <p:nvPr/>
        </p:nvSpPr>
        <p:spPr>
          <a:xfrm>
            <a:off x="8457898" y="5626366"/>
            <a:ext cx="550201" cy="3088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4</a:t>
            </a:r>
            <a:r>
              <a:rPr kumimoji="1" lang="en-US" altLang="ja-JP" sz="1400" dirty="0"/>
              <a:t>00</a:t>
            </a:r>
            <a:endParaRPr kumimoji="1" lang="ja-JP" altLang="en-US" sz="1400"/>
          </a:p>
        </p:txBody>
      </p:sp>
      <p:sp>
        <p:nvSpPr>
          <p:cNvPr id="14" name="テキスト ボックス 15">
            <a:extLst>
              <a:ext uri="{FF2B5EF4-FFF2-40B4-BE49-F238E27FC236}">
                <a16:creationId xmlns:a16="http://schemas.microsoft.com/office/drawing/2014/main" id="{AE50669A-2B02-C546-8E6F-05055EC21DFD}"/>
              </a:ext>
            </a:extLst>
          </p:cNvPr>
          <p:cNvSpPr txBox="1"/>
          <p:nvPr/>
        </p:nvSpPr>
        <p:spPr>
          <a:xfrm>
            <a:off x="10413894" y="5626367"/>
            <a:ext cx="858944" cy="3088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/>
              <a:t>6</a:t>
            </a:r>
            <a:r>
              <a:rPr kumimoji="1" lang="en-US" altLang="ja-JP" sz="1400" dirty="0"/>
              <a:t>00μm</a:t>
            </a:r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3711954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</TotalTime>
  <Words>20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eiryo UI</vt:lpstr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KOU21-391</dc:title>
  <dc:creator>川野 竜太郎</dc:creator>
  <cp:lastModifiedBy>寺井 秀樹</cp:lastModifiedBy>
  <cp:revision>9</cp:revision>
  <dcterms:created xsi:type="dcterms:W3CDTF">2023-07-25T07:46:37Z</dcterms:created>
  <dcterms:modified xsi:type="dcterms:W3CDTF">2023-08-19T06:01:31Z</dcterms:modified>
</cp:coreProperties>
</file>